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  <p:sldId id="259" r:id="rId3"/>
    <p:sldId id="277" r:id="rId4"/>
  </p:sldIdLst>
  <p:sldSz cx="12192000" cy="6858000"/>
  <p:notesSz cx="6858000" cy="9144000"/>
  <p:defaultTextStyle>
    <a:defPPr>
      <a:defRPr lang="en-Q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06" d="100"/>
          <a:sy n="106" d="100"/>
        </p:scale>
        <p:origin x="7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6F283-68A3-04FC-DD65-224748459E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D17E63D-35F6-B1B3-2CA3-69E38690DF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E48895-A6FA-A7EB-871A-E84E65D7B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484CA4-44EF-3729-E5BB-6619FCE872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69BB66-79CD-B4B8-6739-F94EC79AC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4765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AE7CA0-2C13-9162-EFC6-4599CC0D9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BB85B5-F990-853D-EAC2-B5296C25B1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34B75B-3EAF-AE43-AFAC-380EDF6F9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6F5D74-0547-8CEA-6704-21551D9B2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53E58-81F0-7836-3C3F-4E7906B78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065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C3797A3-C4E4-D341-5E7B-B186955894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D36382-BA46-6D13-75D3-D3ACC1D6CD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6766F-65F8-0400-93B9-97858EF75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E74747-51EA-64BA-9149-E4D185D494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DAC8F3-7CAB-A579-D7C5-55BF51510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966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FF538-2E48-DB87-D19A-B97193DE2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198166-847D-DE78-29F0-BB71339B1D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291E68-A4D2-2771-D96F-BD559F316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4E1FE4-06E8-3A7E-3381-76F832F7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6BC3CC-A1A1-3271-1053-40C94E63C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4299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884AB-4409-68F9-EFB4-1B720EEAE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997BB5-65A1-CFA1-C2FA-E42E3C2C5F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1235B0-23F7-F6A8-79C5-837832646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87DAFA-4AFE-E6FA-315A-E9AEF46E33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911CE6-106F-7611-22CB-E11DA8091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543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82059-EA97-44E4-B318-8B562F65DF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DF8EC7-0E50-CB4F-33BE-F872E82FF9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271F2DE-70D9-DBD1-BAA6-68E553B0E2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FC4E1-5D5C-0D01-A3F3-01B27D57F8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B8FB0F-2BD3-1272-39D4-2EE152607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D9CB6-24F9-2963-3ECD-F45B64060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603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29DF81-6942-6324-42FD-307BC96CA1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326653-4596-4009-3DF9-436B321F08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683BC0-B4D1-75DB-A135-18DA30B11C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53EA88-ABF6-52D7-3F12-F2890825E2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3DBBE5-3717-3DA6-EB1E-3DAAA8E90E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976E227-95F7-B415-4266-9A0384579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E2ADD39-4FBD-627F-7FAA-EC7F7C1686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624DA1-58DC-FD66-3289-34DB030FFB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450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36ED6E-0E8C-8F34-8D52-F05FA70BF8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3CCE27-0E4C-4112-0644-BC492C9BF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089D2DE-56B1-7482-88EF-430832796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AE9E35-FF35-8D03-0A02-AF0FCF9912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5443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EB8FBB3-D03C-AF7B-13C0-484A18803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E1FC925-A820-7E90-E85E-7965277621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326574-01E7-FE8A-64E0-E4EFBD934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555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1EAFAA-D1DC-10F2-A289-6C157F8591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E3D898-0496-C7DB-592F-C45F2ACCBA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9C5D2B-E24E-7EF1-2453-D25956871B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91E34C-8886-8B3A-212E-15E545031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298F4E-E72A-E21A-0149-AA3867DEA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F9D4F1-58E2-AA18-0672-FA1404A5C5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361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50AD7B-F4F4-ADFA-EE05-73135CAD45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E4B30F4-6EB7-541E-FCA1-6D25BAB632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62367E-6A4B-0E40-6AB0-66D2DB28DC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F53E5C-E605-770D-21F1-5F3B52E85F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A708B6-24E7-9299-B364-2786F5B687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F30650-CF7B-848C-56EE-EBC3F4E8D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92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F40CDB5-B1D0-41B1-2249-6D929D5707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32B0E8-14A0-F216-CCD8-6F24B0765A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D0362C-B7E5-F87F-F801-112EBF0FAB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969211E-1024-A249-AE9B-03633B9C18B6}" type="datetimeFigureOut">
              <a:rPr lang="en-US" smtClean="0"/>
              <a:t>2025-02-0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F1178E-A0D9-CC3F-2A44-F8B6A04FA6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F5DBEA-6B41-AB38-09F3-8AAAC0449D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82863FE-0121-4448-BA74-09E50898FA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84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Q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tif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2.png"/><Relationship Id="rId4" Type="http://schemas.openxmlformats.org/officeDocument/2006/relationships/image" Target="../media/image7.png"/><Relationship Id="rId9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E84BFF-3C8C-2CE5-3001-C6C0CE119B7B}"/>
              </a:ext>
            </a:extLst>
          </p:cNvPr>
          <p:cNvSpPr txBox="1"/>
          <p:nvPr/>
        </p:nvSpPr>
        <p:spPr>
          <a:xfrm>
            <a:off x="5178774" y="246541"/>
            <a:ext cx="1080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i="1" dirty="0">
                <a:solidFill>
                  <a:srgbClr val="FF0000"/>
                </a:solidFill>
              </a:rPr>
              <a:t>DATA S1</a:t>
            </a:r>
            <a:r>
              <a:rPr lang="en-US" dirty="0"/>
              <a:t>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8934E5E8-3820-6EC4-2A1F-9B60F3D8EC1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-1" r="11131" b="6043"/>
          <a:stretch/>
        </p:blipFill>
        <p:spPr>
          <a:xfrm>
            <a:off x="0" y="2162756"/>
            <a:ext cx="2570392" cy="40342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EB14C5-6E00-90DB-2C76-43A0DEE524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51373" y="2162756"/>
            <a:ext cx="2233947" cy="403424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1F88CF2-F6A9-412A-DD4D-C6D475FEF9AF}"/>
              </a:ext>
            </a:extLst>
          </p:cNvPr>
          <p:cNvSpPr txBox="1"/>
          <p:nvPr/>
        </p:nvSpPr>
        <p:spPr>
          <a:xfrm>
            <a:off x="398534" y="615873"/>
            <a:ext cx="180019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REPB1</a:t>
            </a:r>
          </a:p>
          <a:p>
            <a:r>
              <a:rPr lang="en-QA" dirty="0"/>
              <a:t>60-70, 125</a:t>
            </a:r>
          </a:p>
          <a:p>
            <a:r>
              <a:rPr lang="en-US" b="1" dirty="0"/>
              <a:t>SREBP-1 (E9F4O) Rabbit </a:t>
            </a:r>
            <a:r>
              <a:rPr lang="en-US" b="1" dirty="0" err="1"/>
              <a:t>mAb</a:t>
            </a:r>
            <a:r>
              <a:rPr lang="en-US" b="1" dirty="0"/>
              <a:t> #95879 </a:t>
            </a:r>
          </a:p>
          <a:p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80E23A2-747C-405A-7CDB-893F6CD163C8}"/>
              </a:ext>
            </a:extLst>
          </p:cNvPr>
          <p:cNvSpPr txBox="1"/>
          <p:nvPr/>
        </p:nvSpPr>
        <p:spPr>
          <a:xfrm>
            <a:off x="3126925" y="876828"/>
            <a:ext cx="16925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CD1 (C12H5) Rabbit </a:t>
            </a:r>
            <a:r>
              <a:rPr lang="en-US" b="1" dirty="0" err="1"/>
              <a:t>mAb</a:t>
            </a:r>
            <a:r>
              <a:rPr lang="en-US" b="1" dirty="0"/>
              <a:t> #2794 . </a:t>
            </a:r>
            <a:r>
              <a:rPr lang="en-QA" dirty="0"/>
              <a:t>37kda</a:t>
            </a:r>
            <a:endParaRPr 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774418-B654-3D94-8093-FE77ADA95447}"/>
              </a:ext>
            </a:extLst>
          </p:cNvPr>
          <p:cNvSpPr txBox="1"/>
          <p:nvPr/>
        </p:nvSpPr>
        <p:spPr>
          <a:xfrm>
            <a:off x="5216990" y="1416267"/>
            <a:ext cx="20842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PPARG</a:t>
            </a:r>
          </a:p>
          <a:p>
            <a:pPr algn="ctr"/>
            <a:r>
              <a:rPr lang="en-US" b="1" dirty="0"/>
              <a:t>57 </a:t>
            </a:r>
            <a:r>
              <a:rPr lang="en-US" b="1" dirty="0" err="1"/>
              <a:t>kDa</a:t>
            </a:r>
            <a:r>
              <a:rPr lang="en-US" b="1" dirty="0"/>
              <a:t> and 54 </a:t>
            </a:r>
            <a:r>
              <a:rPr lang="en-US" b="1" dirty="0" err="1"/>
              <a:t>kDa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9218B5D-E703-148E-93EA-4119FCDA1D25}"/>
              </a:ext>
            </a:extLst>
          </p:cNvPr>
          <p:cNvSpPr txBox="1"/>
          <p:nvPr/>
        </p:nvSpPr>
        <p:spPr>
          <a:xfrm>
            <a:off x="7512692" y="1153827"/>
            <a:ext cx="22339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highlight>
                  <a:srgbClr val="FFFF00"/>
                </a:highlight>
              </a:rPr>
              <a:t>FAS: Fatty Acid Synthase Antibody #3189 (273 </a:t>
            </a:r>
            <a:r>
              <a:rPr lang="en-US" dirty="0" err="1">
                <a:highlight>
                  <a:srgbClr val="FFFF00"/>
                </a:highlight>
              </a:rPr>
              <a:t>KDa</a:t>
            </a:r>
            <a:r>
              <a:rPr lang="en-US" dirty="0">
                <a:highlight>
                  <a:srgbClr val="FFFF00"/>
                </a:highlight>
              </a:rPr>
              <a:t>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EC9B024-8D15-BD36-6E9A-51CF231BE598}"/>
              </a:ext>
            </a:extLst>
          </p:cNvPr>
          <p:cNvSpPr txBox="1"/>
          <p:nvPr/>
        </p:nvSpPr>
        <p:spPr>
          <a:xfrm>
            <a:off x="10613646" y="1369257"/>
            <a:ext cx="918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  <a:p>
            <a:r>
              <a:rPr lang="en-US" dirty="0"/>
              <a:t>42 </a:t>
            </a:r>
            <a:r>
              <a:rPr lang="en-US" dirty="0" err="1"/>
              <a:t>kDa</a:t>
            </a:r>
            <a:r>
              <a:rPr lang="en-US" dirty="0"/>
              <a:t>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FD068D5-18C2-7D9E-302B-5F8E8448F606}"/>
              </a:ext>
            </a:extLst>
          </p:cNvPr>
          <p:cNvSpPr txBox="1"/>
          <p:nvPr/>
        </p:nvSpPr>
        <p:spPr>
          <a:xfrm>
            <a:off x="453801" y="2577642"/>
            <a:ext cx="24068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REBP-1 Precursor</a:t>
            </a:r>
          </a:p>
          <a:p>
            <a:endParaRPr lang="en-US" dirty="0">
              <a:solidFill>
                <a:srgbClr val="FF0000"/>
              </a:solidFill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3AE13768-39A1-AA05-4CC7-6CA1CAEDC703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4547" r="30155"/>
          <a:stretch/>
        </p:blipFill>
        <p:spPr>
          <a:xfrm>
            <a:off x="7512692" y="2162756"/>
            <a:ext cx="2233947" cy="395879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1055942-FA8F-2378-DCDF-A649FF796E4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r="64702"/>
          <a:stretch/>
        </p:blipFill>
        <p:spPr>
          <a:xfrm>
            <a:off x="5067332" y="2162756"/>
            <a:ext cx="2233947" cy="395879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4A220848-F756-DB7B-F0AA-EFC8EDF3A30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97203" y="2253029"/>
            <a:ext cx="2239041" cy="395878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AA91ED15-E60E-A0CF-EC74-1D5425C0E66D}"/>
              </a:ext>
            </a:extLst>
          </p:cNvPr>
          <p:cNvSpPr txBox="1"/>
          <p:nvPr/>
        </p:nvSpPr>
        <p:spPr>
          <a:xfrm>
            <a:off x="646333" y="4155605"/>
            <a:ext cx="19461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Nuclear SREBP-1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E4574713-1259-7B13-49C9-07B55A43BCA4}"/>
              </a:ext>
            </a:extLst>
          </p:cNvPr>
          <p:cNvSpPr/>
          <p:nvPr/>
        </p:nvSpPr>
        <p:spPr>
          <a:xfrm>
            <a:off x="7727604" y="2688436"/>
            <a:ext cx="1596867" cy="34352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2211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9EF5B7E-5320-E0B6-8415-9F4EAC2DB93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98303B-0388-D233-8239-3341AB07DD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8500" y="4154337"/>
            <a:ext cx="1330500" cy="17989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CAF94A4-AB56-E9BD-D074-CFE8E44291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41536" y="1203290"/>
            <a:ext cx="2728594" cy="211097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B229823-5126-CD78-9D27-B8D4DDCBBAE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6000" y="1189418"/>
            <a:ext cx="3219450" cy="213871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3FF4314-3CC3-6F00-05FF-0D59E6608D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00817" y="1212290"/>
            <a:ext cx="2596365" cy="2115844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14B137E-56FC-BA3E-4485-7D8307D6FC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1463" y="4195573"/>
            <a:ext cx="2303666" cy="1827575"/>
          </a:xfrm>
          <a:prstGeom prst="rect">
            <a:avLst/>
          </a:prstGeom>
        </p:spPr>
      </p:pic>
      <p:pic>
        <p:nvPicPr>
          <p:cNvPr id="16" name="Picture 15" descr="A close-up of a test&#10;&#10;Description automatically generated">
            <a:extLst>
              <a:ext uri="{FF2B5EF4-FFF2-40B4-BE49-F238E27FC236}">
                <a16:creationId xmlns:a16="http://schemas.microsoft.com/office/drawing/2014/main" id="{869B9865-6D1D-B959-E534-07574518452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1870" y="1347425"/>
            <a:ext cx="1615066" cy="1827575"/>
          </a:xfrm>
          <a:prstGeom prst="rect">
            <a:avLst/>
          </a:prstGeom>
        </p:spPr>
      </p:pic>
      <p:pic>
        <p:nvPicPr>
          <p:cNvPr id="19" name="Picture 18" descr="A close-up of a test&#10;&#10;Description automatically generated">
            <a:extLst>
              <a:ext uri="{FF2B5EF4-FFF2-40B4-BE49-F238E27FC236}">
                <a16:creationId xmlns:a16="http://schemas.microsoft.com/office/drawing/2014/main" id="{0C95DCCB-7A80-AD61-32DA-5586E2776B6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67354" y="1347425"/>
            <a:ext cx="1462059" cy="182757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9460E2B-C2FC-7F2D-BAA2-6D44FCE58132}"/>
              </a:ext>
            </a:extLst>
          </p:cNvPr>
          <p:cNvSpPr txBox="1"/>
          <p:nvPr/>
        </p:nvSpPr>
        <p:spPr>
          <a:xfrm>
            <a:off x="374894" y="45832"/>
            <a:ext cx="2854519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REPB1</a:t>
            </a:r>
          </a:p>
          <a:p>
            <a:r>
              <a:rPr lang="en-QA" dirty="0"/>
              <a:t>60-70, 125</a:t>
            </a:r>
          </a:p>
          <a:p>
            <a:r>
              <a:rPr lang="en-US" b="1" dirty="0"/>
              <a:t>SREBP-1 (E9F4O) Rabbit </a:t>
            </a:r>
            <a:r>
              <a:rPr lang="en-US" b="1" dirty="0" err="1"/>
              <a:t>mAb</a:t>
            </a:r>
            <a:r>
              <a:rPr lang="en-US" b="1" dirty="0"/>
              <a:t> #95879 </a:t>
            </a:r>
          </a:p>
          <a:p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7F0AD4-4FEA-42A5-17AE-A3BDB604EDD3}"/>
              </a:ext>
            </a:extLst>
          </p:cNvPr>
          <p:cNvSpPr txBox="1"/>
          <p:nvPr/>
        </p:nvSpPr>
        <p:spPr>
          <a:xfrm>
            <a:off x="3833010" y="360912"/>
            <a:ext cx="169259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CD1 (C12H5) Rabbit </a:t>
            </a:r>
            <a:r>
              <a:rPr lang="en-US" b="1" dirty="0" err="1"/>
              <a:t>mAb</a:t>
            </a:r>
            <a:r>
              <a:rPr lang="en-US" b="1" dirty="0"/>
              <a:t> #2794 . </a:t>
            </a:r>
            <a:r>
              <a:rPr lang="en-QA" dirty="0"/>
              <a:t>37kda</a:t>
            </a:r>
            <a:endParaRPr lang="en-US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096DE6E-FB5A-7912-0167-CC98D46FA142}"/>
              </a:ext>
            </a:extLst>
          </p:cNvPr>
          <p:cNvSpPr txBox="1"/>
          <p:nvPr/>
        </p:nvSpPr>
        <p:spPr>
          <a:xfrm>
            <a:off x="6545376" y="470223"/>
            <a:ext cx="20842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PPARG</a:t>
            </a:r>
          </a:p>
          <a:p>
            <a:pPr algn="ctr"/>
            <a:r>
              <a:rPr lang="en-US" b="1" dirty="0"/>
              <a:t>57 </a:t>
            </a:r>
            <a:r>
              <a:rPr lang="en-US" b="1" dirty="0" err="1"/>
              <a:t>kDa</a:t>
            </a:r>
            <a:r>
              <a:rPr lang="en-US" b="1" dirty="0"/>
              <a:t> and 54 </a:t>
            </a:r>
            <a:r>
              <a:rPr lang="en-US" b="1" dirty="0" err="1"/>
              <a:t>kDa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A144D59-9FB7-28A5-6F03-6F1128901D13}"/>
              </a:ext>
            </a:extLst>
          </p:cNvPr>
          <p:cNvSpPr txBox="1"/>
          <p:nvPr/>
        </p:nvSpPr>
        <p:spPr>
          <a:xfrm>
            <a:off x="9414268" y="266088"/>
            <a:ext cx="22339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highlight>
                  <a:srgbClr val="FFFF00"/>
                </a:highlight>
              </a:rPr>
              <a:t>FAS: Fatty Acid Synthase Antibody #3189 (273 </a:t>
            </a:r>
            <a:r>
              <a:rPr lang="en-US" dirty="0" err="1">
                <a:highlight>
                  <a:srgbClr val="FFFF00"/>
                </a:highlight>
              </a:rPr>
              <a:t>KDa</a:t>
            </a:r>
            <a:r>
              <a:rPr lang="en-US" dirty="0">
                <a:highlight>
                  <a:srgbClr val="FFFF00"/>
                </a:highlight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5EDE027-A201-37A3-D5A9-4F6D65EB9525}"/>
              </a:ext>
            </a:extLst>
          </p:cNvPr>
          <p:cNvSpPr txBox="1"/>
          <p:nvPr/>
        </p:nvSpPr>
        <p:spPr>
          <a:xfrm>
            <a:off x="929403" y="3513117"/>
            <a:ext cx="91858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-actin</a:t>
            </a:r>
          </a:p>
          <a:p>
            <a:r>
              <a:rPr lang="en-US" dirty="0"/>
              <a:t>42 </a:t>
            </a:r>
            <a:r>
              <a:rPr lang="en-US" dirty="0" err="1"/>
              <a:t>kDa</a:t>
            </a:r>
            <a:r>
              <a:rPr lang="en-US" dirty="0"/>
              <a:t> 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1A728B0F-6CEC-DC12-294F-40DFE602C02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93740" y="3744144"/>
            <a:ext cx="5359400" cy="28448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1DEEE22-D44E-C94B-4980-EED286F14B0C}"/>
              </a:ext>
            </a:extLst>
          </p:cNvPr>
          <p:cNvSpPr txBox="1"/>
          <p:nvPr/>
        </p:nvSpPr>
        <p:spPr>
          <a:xfrm>
            <a:off x="248304" y="2104299"/>
            <a:ext cx="128568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Nuclear SREBP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39F3811-251A-5E1A-6AE3-01F4A3611EAE}"/>
              </a:ext>
            </a:extLst>
          </p:cNvPr>
          <p:cNvSpPr txBox="1"/>
          <p:nvPr/>
        </p:nvSpPr>
        <p:spPr>
          <a:xfrm>
            <a:off x="203490" y="1392355"/>
            <a:ext cx="1330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</a:rPr>
              <a:t>SREBP-1 Precursor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E77102D-4DF2-0164-FC26-2A1ADBA2BAD5}"/>
              </a:ext>
            </a:extLst>
          </p:cNvPr>
          <p:cNvSpPr/>
          <p:nvPr/>
        </p:nvSpPr>
        <p:spPr>
          <a:xfrm>
            <a:off x="9414268" y="1248146"/>
            <a:ext cx="1113364" cy="22206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7F615D1E-C4BB-844F-D0E6-C32FD7BCFD7C}"/>
              </a:ext>
            </a:extLst>
          </p:cNvPr>
          <p:cNvSpPr/>
          <p:nvPr/>
        </p:nvSpPr>
        <p:spPr>
          <a:xfrm>
            <a:off x="10705833" y="1125365"/>
            <a:ext cx="1113364" cy="22206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D9D6C7-CB2C-5DD2-2CBC-10CE03C90C25}"/>
              </a:ext>
            </a:extLst>
          </p:cNvPr>
          <p:cNvSpPr txBox="1"/>
          <p:nvPr/>
        </p:nvSpPr>
        <p:spPr>
          <a:xfrm>
            <a:off x="2592715" y="11996"/>
            <a:ext cx="609399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i="1" dirty="0">
                <a:solidFill>
                  <a:srgbClr val="FF0000"/>
                </a:solidFill>
              </a:rPr>
              <a:t>DATA S1</a:t>
            </a:r>
          </a:p>
        </p:txBody>
      </p:sp>
    </p:spTree>
    <p:extLst>
      <p:ext uri="{BB962C8B-B14F-4D97-AF65-F5344CB8AC3E}">
        <p14:creationId xmlns:p14="http://schemas.microsoft.com/office/powerpoint/2010/main" val="23370702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6348C30-6C46-213B-4623-FEEC42CD77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5300" y="847090"/>
            <a:ext cx="5943600" cy="33159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11D62E0-74A4-3259-383E-D9D90B812DB1}"/>
              </a:ext>
            </a:extLst>
          </p:cNvPr>
          <p:cNvSpPr txBox="1"/>
          <p:nvPr/>
        </p:nvSpPr>
        <p:spPr>
          <a:xfrm>
            <a:off x="790575" y="4163060"/>
            <a:ext cx="10972800" cy="1564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endParaRPr lang="en-US" sz="14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342900" indent="-342900">
              <a:lnSpc>
                <a:spcPct val="115000"/>
              </a:lnSpc>
              <a:buAutoNum type="alphaUcPeriod"/>
            </a:pPr>
            <a:r>
              <a:rPr lang="en-US" sz="1400" dirty="0"/>
              <a:t>Confocal imaging of lipid droplets after staining with 0.2 mM BODIPY 493/503 (green) and DAPI (blue). The white dots in the bright field images indicate lipid droplets </a:t>
            </a:r>
          </a:p>
          <a:p>
            <a:pPr marL="342900" indent="-342900">
              <a:lnSpc>
                <a:spcPct val="115000"/>
              </a:lnSpc>
              <a:buAutoNum type="alphaUcPeriod"/>
            </a:pPr>
            <a:r>
              <a:rPr lang="en-US" sz="1400" dirty="0"/>
              <a:t>Quantification of the lipid content with the BODIPY/DAPI fluorescence ratio in the presence of OA or OA + EX-4. We analyzed 200 cells for each condition. The expression levels were normalized to the level of </a:t>
            </a:r>
            <a:r>
              <a:rPr lang="el-GR" sz="1400" dirty="0"/>
              <a:t>β-</a:t>
            </a:r>
            <a:r>
              <a:rPr lang="en-US" sz="1400" dirty="0"/>
              <a:t>actin. All values are expressed as the mean ± SE (n = 6). *p &lt; 0.05, **p &lt; 0.01, ***p &lt; 0.001.</a:t>
            </a:r>
            <a:r>
              <a:rPr lang="en-US" sz="1400" kern="100" dirty="0">
                <a:solidFill>
                  <a:srgbClr val="FF0000"/>
                </a:solidFill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endParaRPr lang="en-QA" sz="1600" kern="100" dirty="0">
              <a:effectLst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2A35BC-5F1C-14FC-62C4-36E5AA6BE127}"/>
              </a:ext>
            </a:extLst>
          </p:cNvPr>
          <p:cNvSpPr txBox="1"/>
          <p:nvPr/>
        </p:nvSpPr>
        <p:spPr>
          <a:xfrm>
            <a:off x="2505075" y="224274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i="1" dirty="0">
                <a:solidFill>
                  <a:srgbClr val="FF0000"/>
                </a:solidFill>
              </a:rPr>
              <a:t>DATA S2</a:t>
            </a:r>
          </a:p>
        </p:txBody>
      </p:sp>
    </p:spTree>
    <p:extLst>
      <p:ext uri="{BB962C8B-B14F-4D97-AF65-F5344CB8AC3E}">
        <p14:creationId xmlns:p14="http://schemas.microsoft.com/office/powerpoint/2010/main" val="3806403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202</Words>
  <Application>Microsoft Office PowerPoint</Application>
  <PresentationFormat>Widescreen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r. Olfa Khalifa</dc:creator>
  <cp:lastModifiedBy>MDPI</cp:lastModifiedBy>
  <cp:revision>2</cp:revision>
  <dcterms:created xsi:type="dcterms:W3CDTF">2025-01-21T08:18:13Z</dcterms:created>
  <dcterms:modified xsi:type="dcterms:W3CDTF">2025-02-04T11:21:27Z</dcterms:modified>
</cp:coreProperties>
</file>